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85ED5B-2941-4CA6-9A39-C42018BD2D1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5BF0FF-AA68-414D-961B-FD56A7B1958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7A576-3F82-4CFB-B6B0-A0FCA1DD4F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6C636-DBE3-43A2-8AD4-1FC655EE8C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03C77-2820-4965-B1EB-BF6F575A15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91539-4488-4863-973A-D8900BFF4F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66DEF-56D5-43D7-B30D-00BCB06C1D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35024-0BF9-4FF1-BB3B-20EECDB18A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FCBD3-8221-45BD-9751-5B912FBEF3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8C826-C17D-4692-94DC-1060055533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BFB7A-A878-4DB5-B98F-2E09D2B9AA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708A3-B78A-41DA-9A97-BFC5CE8FD4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F84F5-C0F7-4CD1-99BF-05B61C7A99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0ED57-5B5C-4D3F-BACC-CED0238258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425DF8-E9CB-4AF7-A3F1-21CAE5842DE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roysonali2005@gmail.com" TargetMode="External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228600" y="455400"/>
            <a:ext cx="8763120" cy="56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rsenic induced instrumental genes of apoptotic signal amplification in death-survival interplay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nali Roy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1*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, Bardwi Narzary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,  Atish Ray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, Manobjyoti Bordoloi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atural Product Chemistry Group, CSIR-NEIST, Jorhat Assam 785006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2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mmunobiology Laboratory, Department of Zoology, University of Delh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elhi 11000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ddress for correspondenc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nali Ro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atural Product Chemistry Group, CSIR-NEIST, Jorhat Assam  785006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h +91 9678007196; email  </a:t>
            </a:r>
            <a:r>
              <a:rPr b="0" lang="en-US" sz="1600" spc="-1" strike="noStrike" u="sng">
                <a:solidFill>
                  <a:srgbClr val="0000ff"/>
                </a:solidFill>
                <a:uFillTx/>
                <a:latin typeface="Arial"/>
                <a:hlinkClick r:id="rId1"/>
              </a:rPr>
              <a:t>roysonali2005@gmail.co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mails and Ph No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nali Roy: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: roysonali2005@gmail.com  Ph+91 967800719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ardwi Narzar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lang="en-US" sz="1600" spc="-1" strike="noStrike" u="sng">
                <a:solidFill>
                  <a:srgbClr val="0000ff"/>
                </a:solidFill>
                <a:uFillTx/>
                <a:latin typeface="Arial"/>
              </a:rPr>
              <a:t>bardwinarzary@yahoo.com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;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h +91 8473895097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tish Ray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: ray.atish@gmail.com;  Ph +91 813013189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anobjyoti Brdoloi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   : </a:t>
            </a:r>
            <a:r>
              <a:rPr b="0" lang="en-US" sz="1600" spc="-1" strike="noStrike" u="sng">
                <a:solidFill>
                  <a:srgbClr val="0000ff"/>
                </a:solidFill>
                <a:uFillTx/>
                <a:latin typeface="Arial"/>
              </a:rPr>
              <a:t>mjb_rrljt@yahoo.co.i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; Ph +91 943547853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unning title: Arsenic mediated amplification of apoptotic signa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2209680" y="380880"/>
            <a:ext cx="4572000" cy="4491000"/>
          </a:xfrm>
          <a:prstGeom prst="rect">
            <a:avLst/>
          </a:prstGeom>
          <a:ln w="0">
            <a:noFill/>
          </a:ln>
        </p:spPr>
      </p:pic>
      <p:sp>
        <p:nvSpPr>
          <p:cNvPr id="50" name="TextBox 2"/>
          <p:cNvSpPr/>
          <p:nvPr/>
        </p:nvSpPr>
        <p:spPr>
          <a:xfrm>
            <a:off x="325440" y="228600"/>
            <a:ext cx="223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data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"/>
          <p:cNvSpPr/>
          <p:nvPr/>
        </p:nvSpPr>
        <p:spPr>
          <a:xfrm>
            <a:off x="719280" y="4648320"/>
            <a:ext cx="797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ll treatment regimens between 1µM and 10µM  are  significant (p&lt; .05)as compared to concurrent contro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4"/>
          <p:cNvSpPr/>
          <p:nvPr/>
        </p:nvSpPr>
        <p:spPr>
          <a:xfrm>
            <a:off x="990720" y="5257800"/>
            <a:ext cx="73152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ime and concentration kinetics of cell death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ime and concentration dependent cell death is observed in arsenic exposed HepG2 cells. Figure demonstrate ~ 50% cell death is achieved at 12 h in presence of 10 μM arsenic while 1 μM exhibits no cell death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9T06:03:04Z</dcterms:created>
  <dc:creator>Atish Ray</dc:creator>
  <dc:description/>
  <dc:language>en-US</dc:language>
  <cp:lastModifiedBy>Atish Ray</cp:lastModifiedBy>
  <dcterms:modified xsi:type="dcterms:W3CDTF">2016-05-14T07:09:16Z</dcterms:modified>
  <cp:revision>5</cp:revision>
  <dc:subject/>
  <dc:title>Slide 1</dc:title>
</cp:coreProperties>
</file>